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11"/>
  </p:notesMasterIdLst>
  <p:sldIdLst>
    <p:sldId id="265" r:id="rId2"/>
    <p:sldId id="256" r:id="rId3"/>
    <p:sldId id="263" r:id="rId4"/>
    <p:sldId id="258" r:id="rId5"/>
    <p:sldId id="262" r:id="rId6"/>
    <p:sldId id="259" r:id="rId7"/>
    <p:sldId id="260" r:id="rId8"/>
    <p:sldId id="264" r:id="rId9"/>
    <p:sldId id="261" r:id="rId10"/>
  </p:sldIdLst>
  <p:sldSz cx="6480175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27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9300C7-936E-4E6A-92C1-9FC93E2680A6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39938" y="1143000"/>
            <a:ext cx="2778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75E097-BEB5-413B-ACBD-B0FEC44071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5359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44231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1pPr>
    <a:lvl2pPr marL="422116" algn="l" defTabSz="844231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2pPr>
    <a:lvl3pPr marL="844231" algn="l" defTabSz="844231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3pPr>
    <a:lvl4pPr marL="1266346" algn="l" defTabSz="844231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4pPr>
    <a:lvl5pPr marL="1688461" algn="l" defTabSz="844231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5pPr>
    <a:lvl6pPr marL="2110577" algn="l" defTabSz="844231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6pPr>
    <a:lvl7pPr marL="2532692" algn="l" defTabSz="844231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7pPr>
    <a:lvl8pPr marL="2954807" algn="l" defTabSz="844231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8pPr>
    <a:lvl9pPr marL="3376923" algn="l" defTabSz="844231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7" y="1178226"/>
            <a:ext cx="5508149" cy="2506427"/>
          </a:xfrm>
        </p:spPr>
        <p:txBody>
          <a:bodyPr anchor="b"/>
          <a:lstStyle>
            <a:lvl1pPr algn="ctr">
              <a:defRPr sz="425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3781309"/>
            <a:ext cx="4860132" cy="1738167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20" indent="0" algn="ctr">
              <a:buNone/>
              <a:defRPr sz="1417"/>
            </a:lvl2pPr>
            <a:lvl3pPr marL="648036" indent="0" algn="ctr">
              <a:buNone/>
              <a:defRPr sz="1276"/>
            </a:lvl3pPr>
            <a:lvl4pPr marL="972056" indent="0" algn="ctr">
              <a:buNone/>
              <a:defRPr sz="1134"/>
            </a:lvl4pPr>
            <a:lvl5pPr marL="1296074" indent="0" algn="ctr">
              <a:buNone/>
              <a:defRPr sz="1134"/>
            </a:lvl5pPr>
            <a:lvl6pPr marL="1620094" indent="0" algn="ctr">
              <a:buNone/>
              <a:defRPr sz="1134"/>
            </a:lvl6pPr>
            <a:lvl7pPr marL="1944112" indent="0" algn="ctr">
              <a:buNone/>
              <a:defRPr sz="1134"/>
            </a:lvl7pPr>
            <a:lvl8pPr marL="2268130" indent="0" algn="ctr">
              <a:buNone/>
              <a:defRPr sz="1134"/>
            </a:lvl8pPr>
            <a:lvl9pPr marL="2592149" indent="0" algn="ctr">
              <a:buNone/>
              <a:defRPr sz="113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975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64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6" y="383300"/>
            <a:ext cx="1397288" cy="610108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8" y="383300"/>
            <a:ext cx="4110861" cy="610108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179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879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43" y="1794833"/>
            <a:ext cx="5589151" cy="2994714"/>
          </a:xfrm>
        </p:spPr>
        <p:txBody>
          <a:bodyPr anchor="b"/>
          <a:lstStyle>
            <a:lvl1pPr>
              <a:defRPr sz="425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43" y="4817878"/>
            <a:ext cx="5589151" cy="1574849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>
                    <a:tint val="82000"/>
                  </a:schemeClr>
                </a:solidFill>
              </a:defRPr>
            </a:lvl1pPr>
            <a:lvl2pPr marL="324020" indent="0">
              <a:buNone/>
              <a:defRPr sz="1417">
                <a:solidFill>
                  <a:schemeClr val="tx1">
                    <a:tint val="82000"/>
                  </a:schemeClr>
                </a:solidFill>
              </a:defRPr>
            </a:lvl2pPr>
            <a:lvl3pPr marL="648036" indent="0">
              <a:buNone/>
              <a:defRPr sz="1276">
                <a:solidFill>
                  <a:schemeClr val="tx1">
                    <a:tint val="82000"/>
                  </a:schemeClr>
                </a:solidFill>
              </a:defRPr>
            </a:lvl3pPr>
            <a:lvl4pPr marL="972056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4pPr>
            <a:lvl5pPr marL="1296074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5pPr>
            <a:lvl6pPr marL="1620094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6pPr>
            <a:lvl7pPr marL="1944112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7pPr>
            <a:lvl8pPr marL="2268130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8pPr>
            <a:lvl9pPr marL="2592149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660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3" y="1916484"/>
            <a:ext cx="2754074" cy="456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916484"/>
            <a:ext cx="2754074" cy="456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002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9" y="383300"/>
            <a:ext cx="5589151" cy="13915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62" y="1764836"/>
            <a:ext cx="2741417" cy="86491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20" indent="0">
              <a:buNone/>
              <a:defRPr sz="1417" b="1"/>
            </a:lvl2pPr>
            <a:lvl3pPr marL="648036" indent="0">
              <a:buNone/>
              <a:defRPr sz="1276" b="1"/>
            </a:lvl3pPr>
            <a:lvl4pPr marL="972056" indent="0">
              <a:buNone/>
              <a:defRPr sz="1134" b="1"/>
            </a:lvl4pPr>
            <a:lvl5pPr marL="1296074" indent="0">
              <a:buNone/>
              <a:defRPr sz="1134" b="1"/>
            </a:lvl5pPr>
            <a:lvl6pPr marL="1620094" indent="0">
              <a:buNone/>
              <a:defRPr sz="1134" b="1"/>
            </a:lvl6pPr>
            <a:lvl7pPr marL="1944112" indent="0">
              <a:buNone/>
              <a:defRPr sz="1134" b="1"/>
            </a:lvl7pPr>
            <a:lvl8pPr marL="2268130" indent="0">
              <a:buNone/>
              <a:defRPr sz="1134" b="1"/>
            </a:lvl8pPr>
            <a:lvl9pPr marL="2592149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62" y="2629753"/>
            <a:ext cx="2741417" cy="3867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90" y="1764836"/>
            <a:ext cx="2754918" cy="86491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20" indent="0">
              <a:buNone/>
              <a:defRPr sz="1417" b="1"/>
            </a:lvl2pPr>
            <a:lvl3pPr marL="648036" indent="0">
              <a:buNone/>
              <a:defRPr sz="1276" b="1"/>
            </a:lvl3pPr>
            <a:lvl4pPr marL="972056" indent="0">
              <a:buNone/>
              <a:defRPr sz="1134" b="1"/>
            </a:lvl4pPr>
            <a:lvl5pPr marL="1296074" indent="0">
              <a:buNone/>
              <a:defRPr sz="1134" b="1"/>
            </a:lvl5pPr>
            <a:lvl6pPr marL="1620094" indent="0">
              <a:buNone/>
              <a:defRPr sz="1134" b="1"/>
            </a:lvl6pPr>
            <a:lvl7pPr marL="1944112" indent="0">
              <a:buNone/>
              <a:defRPr sz="1134" b="1"/>
            </a:lvl7pPr>
            <a:lvl8pPr marL="2268130" indent="0">
              <a:buNone/>
              <a:defRPr sz="1134" b="1"/>
            </a:lvl8pPr>
            <a:lvl9pPr marL="2592149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90" y="2629753"/>
            <a:ext cx="2754918" cy="3867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719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110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985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62" y="479954"/>
            <a:ext cx="2090025" cy="167984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23" y="1036571"/>
            <a:ext cx="3280589" cy="5116178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62" y="2159797"/>
            <a:ext cx="2090025" cy="4001285"/>
          </a:xfrm>
        </p:spPr>
        <p:txBody>
          <a:bodyPr/>
          <a:lstStyle>
            <a:lvl1pPr marL="0" indent="0">
              <a:buNone/>
              <a:defRPr sz="1134"/>
            </a:lvl1pPr>
            <a:lvl2pPr marL="324020" indent="0">
              <a:buNone/>
              <a:defRPr sz="992"/>
            </a:lvl2pPr>
            <a:lvl3pPr marL="648036" indent="0">
              <a:buNone/>
              <a:defRPr sz="850"/>
            </a:lvl3pPr>
            <a:lvl4pPr marL="972056" indent="0">
              <a:buNone/>
              <a:defRPr sz="709"/>
            </a:lvl4pPr>
            <a:lvl5pPr marL="1296074" indent="0">
              <a:buNone/>
              <a:defRPr sz="709"/>
            </a:lvl5pPr>
            <a:lvl6pPr marL="1620094" indent="0">
              <a:buNone/>
              <a:defRPr sz="709"/>
            </a:lvl6pPr>
            <a:lvl7pPr marL="1944112" indent="0">
              <a:buNone/>
              <a:defRPr sz="709"/>
            </a:lvl7pPr>
            <a:lvl8pPr marL="2268130" indent="0">
              <a:buNone/>
              <a:defRPr sz="709"/>
            </a:lvl8pPr>
            <a:lvl9pPr marL="2592149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920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62" y="479954"/>
            <a:ext cx="2090025" cy="167984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23" y="1036571"/>
            <a:ext cx="3280589" cy="5116178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20" indent="0">
              <a:buNone/>
              <a:defRPr sz="1984"/>
            </a:lvl2pPr>
            <a:lvl3pPr marL="648036" indent="0">
              <a:buNone/>
              <a:defRPr sz="1701"/>
            </a:lvl3pPr>
            <a:lvl4pPr marL="972056" indent="0">
              <a:buNone/>
              <a:defRPr sz="1417"/>
            </a:lvl4pPr>
            <a:lvl5pPr marL="1296074" indent="0">
              <a:buNone/>
              <a:defRPr sz="1417"/>
            </a:lvl5pPr>
            <a:lvl6pPr marL="1620094" indent="0">
              <a:buNone/>
              <a:defRPr sz="1417"/>
            </a:lvl6pPr>
            <a:lvl7pPr marL="1944112" indent="0">
              <a:buNone/>
              <a:defRPr sz="1417"/>
            </a:lvl7pPr>
            <a:lvl8pPr marL="2268130" indent="0">
              <a:buNone/>
              <a:defRPr sz="1417"/>
            </a:lvl8pPr>
            <a:lvl9pPr marL="2592149" indent="0">
              <a:buNone/>
              <a:defRPr sz="141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62" y="2159797"/>
            <a:ext cx="2090025" cy="4001285"/>
          </a:xfrm>
        </p:spPr>
        <p:txBody>
          <a:bodyPr/>
          <a:lstStyle>
            <a:lvl1pPr marL="0" indent="0">
              <a:buNone/>
              <a:defRPr sz="1134"/>
            </a:lvl1pPr>
            <a:lvl2pPr marL="324020" indent="0">
              <a:buNone/>
              <a:defRPr sz="992"/>
            </a:lvl2pPr>
            <a:lvl3pPr marL="648036" indent="0">
              <a:buNone/>
              <a:defRPr sz="850"/>
            </a:lvl3pPr>
            <a:lvl4pPr marL="972056" indent="0">
              <a:buNone/>
              <a:defRPr sz="709"/>
            </a:lvl4pPr>
            <a:lvl5pPr marL="1296074" indent="0">
              <a:buNone/>
              <a:defRPr sz="709"/>
            </a:lvl5pPr>
            <a:lvl6pPr marL="1620094" indent="0">
              <a:buNone/>
              <a:defRPr sz="709"/>
            </a:lvl6pPr>
            <a:lvl7pPr marL="1944112" indent="0">
              <a:buNone/>
              <a:defRPr sz="709"/>
            </a:lvl7pPr>
            <a:lvl8pPr marL="2268130" indent="0">
              <a:buNone/>
              <a:defRPr sz="709"/>
            </a:lvl8pPr>
            <a:lvl9pPr marL="2592149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669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7" y="383300"/>
            <a:ext cx="5589151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7" y="1916484"/>
            <a:ext cx="5589151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7" y="6672700"/>
            <a:ext cx="1458039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94847A-AFDA-4897-83BE-5CC40E4A19CA}" type="datetimeFigureOut">
              <a:rPr lang="en-US" smtClean="0"/>
              <a:t>12-Mar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63" y="6672700"/>
            <a:ext cx="2187059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30" y="6672700"/>
            <a:ext cx="1458039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D38D4D-5678-4088-AFF2-ECCF9AB5E4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554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48036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10" indent="-162010" algn="l" defTabSz="648036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8" indent="-162010" algn="l" defTabSz="648036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7" indent="-162010" algn="l" defTabSz="648036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5" indent="-162010" algn="l" defTabSz="648036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84" indent="-162010" algn="l" defTabSz="648036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101" indent="-162010" algn="l" defTabSz="648036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21" indent="-162010" algn="l" defTabSz="648036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40" indent="-162010" algn="l" defTabSz="648036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9" indent="-162010" algn="l" defTabSz="648036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6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20" algn="l" defTabSz="648036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6" algn="l" defTabSz="648036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6" algn="l" defTabSz="648036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4" algn="l" defTabSz="648036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94" algn="l" defTabSz="648036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12" algn="l" defTabSz="648036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30" algn="l" defTabSz="648036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9" algn="l" defTabSz="648036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1728A7E1-74A9-F307-59AA-FCB121B609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45507" y="1315707"/>
            <a:ext cx="5589151" cy="4567898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Summary of findings tables </a:t>
            </a:r>
          </a:p>
        </p:txBody>
      </p:sp>
      <p:sp>
        <p:nvSpPr>
          <p:cNvPr id="9" name="Title 8">
            <a:extLst>
              <a:ext uri="{FF2B5EF4-FFF2-40B4-BE49-F238E27FC236}">
                <a16:creationId xmlns:a16="http://schemas.microsoft.com/office/drawing/2014/main" id="{82993CD5-CF18-0661-08FE-A67530D7C6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400" dirty="0"/>
              <a:t>Multimedia Appendix 8</a:t>
            </a:r>
          </a:p>
        </p:txBody>
      </p:sp>
    </p:spTree>
    <p:extLst>
      <p:ext uri="{BB962C8B-B14F-4D97-AF65-F5344CB8AC3E}">
        <p14:creationId xmlns:p14="http://schemas.microsoft.com/office/powerpoint/2010/main" val="41752990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105926-6C96-F9C0-D3FE-74B9E269DE6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E04B00-A267-349D-5786-AB44437980E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  <p:pic>
        <p:nvPicPr>
          <p:cNvPr id="5" name="Picture 4" descr="A close-up of a document&#10;&#10;Description automatically generated">
            <a:extLst>
              <a:ext uri="{FF2B5EF4-FFF2-40B4-BE49-F238E27FC236}">
                <a16:creationId xmlns:a16="http://schemas.microsoft.com/office/drawing/2014/main" id="{B1C7A073-FAC8-F6D6-7F30-18102BB2D2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702" y="261614"/>
            <a:ext cx="5777592" cy="684404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38F99B82-0091-1AB3-7D7F-D04776886A52}"/>
              </a:ext>
            </a:extLst>
          </p:cNvPr>
          <p:cNvSpPr txBox="1"/>
          <p:nvPr/>
        </p:nvSpPr>
        <p:spPr>
          <a:xfrm>
            <a:off x="-3" y="0"/>
            <a:ext cx="32385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DAS-Cog summary of findings.</a:t>
            </a:r>
          </a:p>
        </p:txBody>
      </p:sp>
    </p:spTree>
    <p:extLst>
      <p:ext uri="{BB962C8B-B14F-4D97-AF65-F5344CB8AC3E}">
        <p14:creationId xmlns:p14="http://schemas.microsoft.com/office/powerpoint/2010/main" val="2234446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5FD6C2-607A-2F18-E15E-1FDF0350EF7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7B81863-E767-4EBA-33B6-90873C5E5FB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3C296A7-C2EA-C952-6DAA-370D76CCB359}"/>
              </a:ext>
            </a:extLst>
          </p:cNvPr>
          <p:cNvSpPr txBox="1"/>
          <p:nvPr/>
        </p:nvSpPr>
        <p:spPr>
          <a:xfrm>
            <a:off x="-3" y="0"/>
            <a:ext cx="32385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SE</a:t>
            </a:r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mmary of finding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4007E39-C755-1346-68F6-DC762B2301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9701" y="261610"/>
            <a:ext cx="5777592" cy="60740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15188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14F5285-8BF0-F3E8-AF1D-9C82C37528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60390B-0218-0EE5-4A30-0933BF24DEB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6103D0-740B-17B1-CBE6-4D5EE15C925E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0530E23-2E94-337E-A108-F2D8B494BC08}"/>
              </a:ext>
            </a:extLst>
          </p:cNvPr>
          <p:cNvSpPr txBox="1"/>
          <p:nvPr/>
        </p:nvSpPr>
        <p:spPr>
          <a:xfrm>
            <a:off x="-3" y="0"/>
            <a:ext cx="32385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R</a:t>
            </a:r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B summary of finding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F76C493-F35D-E441-F127-5365FE8516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9702" y="266354"/>
            <a:ext cx="5777592" cy="68345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99071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581BFA9-86F0-7A10-ED9B-A3783B492AA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C50385-7369-E7F9-89DE-739F63466B9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88B106-CDA8-50B1-1851-719E05E5B20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38ABB0A-56A7-899D-DFB9-79211F2F1EC6}"/>
              </a:ext>
            </a:extLst>
          </p:cNvPr>
          <p:cNvSpPr txBox="1"/>
          <p:nvPr/>
        </p:nvSpPr>
        <p:spPr>
          <a:xfrm>
            <a:off x="-3" y="0"/>
            <a:ext cx="32385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olerability summary of findings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BE23266-ED8E-09BE-3DD5-060504C5F7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67"/>
          <a:stretch/>
        </p:blipFill>
        <p:spPr>
          <a:xfrm>
            <a:off x="486009" y="261610"/>
            <a:ext cx="5508149" cy="69511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49121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C717F8F-CBF0-5AE1-DEAE-7127CC718DE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98C848-A413-9910-3873-32F713B819A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6E7268C-FF9A-A7D9-5103-3812848A5CE2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D20BBC6-B77F-4B53-21F0-1E67C924EC00}"/>
              </a:ext>
            </a:extLst>
          </p:cNvPr>
          <p:cNvSpPr txBox="1"/>
          <p:nvPr/>
        </p:nvSpPr>
        <p:spPr>
          <a:xfrm>
            <a:off x="-3" y="0"/>
            <a:ext cx="3686178" cy="2617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otal events of ARIA-E summary of findings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E86937E-7E6D-A208-171F-02318CAC1A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9180" y="261614"/>
            <a:ext cx="5738635" cy="6844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05408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D413A43-8DA3-2B31-A5EF-9DBB8B7C821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7585FB-F750-5D6A-E182-89A3E1D81DA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763A2E-649E-CBDD-CACA-C2443A56798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BF04AEE-2054-3DC4-7399-910DF5C988E6}"/>
              </a:ext>
            </a:extLst>
          </p:cNvPr>
          <p:cNvSpPr txBox="1"/>
          <p:nvPr/>
        </p:nvSpPr>
        <p:spPr>
          <a:xfrm>
            <a:off x="-3" y="0"/>
            <a:ext cx="3483772" cy="2617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otal events of ARIA-H summary of findings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23201B0-98ED-E0EE-D0FB-0249E0BFEB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9701" y="261610"/>
            <a:ext cx="5777592" cy="65674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55713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0CD3B35-A86D-57BA-47CE-B27C74A0650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52B8C2-44F4-84DA-732F-0F51E8DE401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89C09D1-BACF-C923-03D1-F4092E8C970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D4936D9-0EBA-47AF-EF63-0D96F2A1555A}"/>
              </a:ext>
            </a:extLst>
          </p:cNvPr>
          <p:cNvSpPr txBox="1"/>
          <p:nvPr/>
        </p:nvSpPr>
        <p:spPr>
          <a:xfrm>
            <a:off x="-3" y="0"/>
            <a:ext cx="32385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Headaches summary of findings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CD823AE-69FC-0A5E-D073-D3681A5376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9702" y="265201"/>
            <a:ext cx="5777592" cy="68368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4461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D13367E-6178-DF87-857F-C43F230F52A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6290A0-3794-9BC7-74E2-242EEFA8D59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9AEBCA3-D173-2396-7D4B-6C6A69D625B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54A740A-CE33-3200-A050-033C4637B76C}"/>
              </a:ext>
            </a:extLst>
          </p:cNvPr>
          <p:cNvSpPr txBox="1"/>
          <p:nvPr/>
        </p:nvSpPr>
        <p:spPr>
          <a:xfrm>
            <a:off x="-3" y="0"/>
            <a:ext cx="3648078" cy="2617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r>
              <a:rPr lang="en-US" sz="11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fusion-related reactions summary of findings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7C2BB39-618C-FD05-1ED4-81D7945A67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9701" y="261610"/>
            <a:ext cx="5777592" cy="5999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4316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8</TotalTime>
  <Words>78</Words>
  <Application>Microsoft Office PowerPoint</Application>
  <PresentationFormat>Custom</PresentationFormat>
  <Paragraphs>1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ptos</vt:lpstr>
      <vt:lpstr>Aptos Display</vt:lpstr>
      <vt:lpstr>Arial</vt:lpstr>
      <vt:lpstr>Times New Roman</vt:lpstr>
      <vt:lpstr>Office Theme</vt:lpstr>
      <vt:lpstr>Multimedia Appendix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nko Jeremic</dc:creator>
  <cp:lastModifiedBy>Editor</cp:lastModifiedBy>
  <cp:revision>5</cp:revision>
  <dcterms:created xsi:type="dcterms:W3CDTF">2024-10-24T16:13:03Z</dcterms:created>
  <dcterms:modified xsi:type="dcterms:W3CDTF">2025-03-12T14:39:54Z</dcterms:modified>
</cp:coreProperties>
</file>